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263"/>
    <p:restoredTop sz="94674"/>
  </p:normalViewPr>
  <p:slideViewPr>
    <p:cSldViewPr snapToGrid="0" snapToObjects="1">
      <p:cViewPr>
        <p:scale>
          <a:sx n="155" d="100"/>
          <a:sy n="155" d="100"/>
        </p:scale>
        <p:origin x="2136" y="-3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8391-D868-A647-90F9-E8900B37D873}" type="datetimeFigureOut">
              <a:rPr lang="en-US" smtClean="0"/>
              <a:t>12/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9D178-188B-384A-BB7E-F76ABF99F8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55208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8391-D868-A647-90F9-E8900B37D873}" type="datetimeFigureOut">
              <a:rPr lang="en-US" smtClean="0"/>
              <a:t>12/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9D178-188B-384A-BB7E-F76ABF99F8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97301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8391-D868-A647-90F9-E8900B37D873}" type="datetimeFigureOut">
              <a:rPr lang="en-US" smtClean="0"/>
              <a:t>12/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9D178-188B-384A-BB7E-F76ABF99F8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10509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8391-D868-A647-90F9-E8900B37D873}" type="datetimeFigureOut">
              <a:rPr lang="en-US" smtClean="0"/>
              <a:t>12/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9D178-188B-384A-BB7E-F76ABF99F8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9355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8391-D868-A647-90F9-E8900B37D873}" type="datetimeFigureOut">
              <a:rPr lang="en-US" smtClean="0"/>
              <a:t>12/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9D178-188B-384A-BB7E-F76ABF99F8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7919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8391-D868-A647-90F9-E8900B37D873}" type="datetimeFigureOut">
              <a:rPr lang="en-US" smtClean="0"/>
              <a:t>12/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9D178-188B-384A-BB7E-F76ABF99F8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5233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8391-D868-A647-90F9-E8900B37D873}" type="datetimeFigureOut">
              <a:rPr lang="en-US" smtClean="0"/>
              <a:t>12/9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9D178-188B-384A-BB7E-F76ABF99F8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356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8391-D868-A647-90F9-E8900B37D873}" type="datetimeFigureOut">
              <a:rPr lang="en-US" smtClean="0"/>
              <a:t>12/9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9D178-188B-384A-BB7E-F76ABF99F8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0890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8391-D868-A647-90F9-E8900B37D873}" type="datetimeFigureOut">
              <a:rPr lang="en-US" smtClean="0"/>
              <a:t>12/9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9D178-188B-384A-BB7E-F76ABF99F8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6713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8391-D868-A647-90F9-E8900B37D873}" type="datetimeFigureOut">
              <a:rPr lang="en-US" smtClean="0"/>
              <a:t>12/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9D178-188B-384A-BB7E-F76ABF99F8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1995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8391-D868-A647-90F9-E8900B37D873}" type="datetimeFigureOut">
              <a:rPr lang="en-US" smtClean="0"/>
              <a:t>12/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9D178-188B-384A-BB7E-F76ABF99F8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9072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C28391-D868-A647-90F9-E8900B37D873}" type="datetimeFigureOut">
              <a:rPr lang="en-US" smtClean="0"/>
              <a:t>12/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49D178-188B-384A-BB7E-F76ABF99F8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69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EDEC34A4-FBA4-F549-8376-AFF3A911A94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78056997"/>
              </p:ext>
            </p:extLst>
          </p:nvPr>
        </p:nvGraphicFramePr>
        <p:xfrm>
          <a:off x="98474" y="967316"/>
          <a:ext cx="6625884" cy="7849995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612726">
                  <a:extLst>
                    <a:ext uri="{9D8B030D-6E8A-4147-A177-3AD203B41FA5}">
                      <a16:colId xmlns:a16="http://schemas.microsoft.com/office/drawing/2014/main" val="3583324305"/>
                    </a:ext>
                  </a:extLst>
                </a:gridCol>
                <a:gridCol w="1473200">
                  <a:extLst>
                    <a:ext uri="{9D8B030D-6E8A-4147-A177-3AD203B41FA5}">
                      <a16:colId xmlns:a16="http://schemas.microsoft.com/office/drawing/2014/main" val="1292597837"/>
                    </a:ext>
                  </a:extLst>
                </a:gridCol>
                <a:gridCol w="956733">
                  <a:extLst>
                    <a:ext uri="{9D8B030D-6E8A-4147-A177-3AD203B41FA5}">
                      <a16:colId xmlns:a16="http://schemas.microsoft.com/office/drawing/2014/main" val="3327303595"/>
                    </a:ext>
                  </a:extLst>
                </a:gridCol>
                <a:gridCol w="1032934">
                  <a:extLst>
                    <a:ext uri="{9D8B030D-6E8A-4147-A177-3AD203B41FA5}">
                      <a16:colId xmlns:a16="http://schemas.microsoft.com/office/drawing/2014/main" val="181517149"/>
                    </a:ext>
                  </a:extLst>
                </a:gridCol>
                <a:gridCol w="2550291">
                  <a:extLst>
                    <a:ext uri="{9D8B030D-6E8A-4147-A177-3AD203B41FA5}">
                      <a16:colId xmlns:a16="http://schemas.microsoft.com/office/drawing/2014/main" val="2034705584"/>
                    </a:ext>
                  </a:extLst>
                </a:gridCol>
              </a:tblGrid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s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ssue/Sourc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Bank Accession No.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sest match in GenBank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47969139"/>
                  </a:ext>
                </a:extLst>
              </a:tr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1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modon</a:t>
                      </a:r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spidus</a:t>
                      </a:r>
                      <a:endParaRPr lang="en-US" sz="8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72184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Q296139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35261074"/>
                  </a:ext>
                </a:extLst>
              </a:tr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1-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modon</a:t>
                      </a:r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spidus</a:t>
                      </a:r>
                      <a:endParaRPr lang="en-US" sz="8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72184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Q296139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92556648"/>
                  </a:ext>
                </a:extLst>
              </a:tr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2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 musculu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72184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Q296139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00849336"/>
                  </a:ext>
                </a:extLst>
              </a:tr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2-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 musculu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72184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Q296139.1, EU747301.1, HM046989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14369659"/>
                  </a:ext>
                </a:extLst>
              </a:tr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3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 musculu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72184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Q296139.1, EU747301.1, HM046989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37122076"/>
                  </a:ext>
                </a:extLst>
              </a:tr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3-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 musculu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72185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Q296139.1, EU747301.1, HM046989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86560547"/>
                  </a:ext>
                </a:extLst>
              </a:tr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6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 musculu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72185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Q296139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49619300"/>
                  </a:ext>
                </a:extLst>
              </a:tr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6-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 musculu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72185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J701738.1, DQ296139.1, EU747301.1, HM046989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60106506"/>
                  </a:ext>
                </a:extLst>
              </a:tr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9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 musculu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72185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Q296139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34353595"/>
                  </a:ext>
                </a:extLst>
              </a:tr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9-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 musculu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72185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Q296139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27410958"/>
                  </a:ext>
                </a:extLst>
              </a:tr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14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 musculu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72185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Q296139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07027757"/>
                  </a:ext>
                </a:extLst>
              </a:tr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14-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 musculu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72185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Q296139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77251769"/>
                  </a:ext>
                </a:extLst>
              </a:tr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16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omyscus </a:t>
                      </a:r>
                      <a:r>
                        <a:rPr lang="en-US" sz="8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iculatus</a:t>
                      </a:r>
                      <a:endParaRPr lang="en-US" sz="8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72185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Q296139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35130889"/>
                  </a:ext>
                </a:extLst>
              </a:tr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16-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omyscus </a:t>
                      </a:r>
                      <a:r>
                        <a:rPr lang="en-US" sz="8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iculatus</a:t>
                      </a:r>
                      <a:endParaRPr lang="en-US" sz="8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72185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Q296139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0035090"/>
                  </a:ext>
                </a:extLst>
              </a:tr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17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 musculu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72185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Q296139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19294781"/>
                  </a:ext>
                </a:extLst>
              </a:tr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17-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 musculu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72186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Q296139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64893305"/>
                  </a:ext>
                </a:extLst>
              </a:tr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F3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omyscus </a:t>
                      </a:r>
                      <a:r>
                        <a:rPr lang="en-US" sz="8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iculatus</a:t>
                      </a:r>
                      <a:endParaRPr lang="en-US" sz="8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72186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022885.1, CP011410.1, EU747299.1, EU747311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52109803"/>
                  </a:ext>
                </a:extLst>
              </a:tr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F3-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omyscus </a:t>
                      </a:r>
                      <a:r>
                        <a:rPr lang="en-US" sz="8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iculatus</a:t>
                      </a:r>
                      <a:endParaRPr lang="en-US" sz="8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72186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022885.1, CP011410.1, EU747299.1, EU747311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74298436"/>
                  </a:ext>
                </a:extLst>
              </a:tr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F4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omyscus </a:t>
                      </a:r>
                      <a:r>
                        <a:rPr lang="en-US" sz="8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iculatus</a:t>
                      </a:r>
                      <a:endParaRPr lang="en-US" sz="8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72186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022885.1, CP011410.1, EU747299.1, EU747311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4480306"/>
                  </a:ext>
                </a:extLst>
              </a:tr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F4-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omyscus </a:t>
                      </a:r>
                      <a:r>
                        <a:rPr lang="en-US" sz="8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iculatus</a:t>
                      </a:r>
                      <a:endParaRPr lang="en-US" sz="8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72186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022885.1, CP011410.1, EU747299.1, EU747311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13114710"/>
                  </a:ext>
                </a:extLst>
              </a:tr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F9-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omyscus </a:t>
                      </a:r>
                      <a:r>
                        <a:rPr lang="en-US" sz="8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iculatus</a:t>
                      </a:r>
                      <a:endParaRPr lang="en-US" sz="8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72186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022885.1, CP011410.1, EU747299.1, EU747311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14251952"/>
                  </a:ext>
                </a:extLst>
              </a:tr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WT2-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modon</a:t>
                      </a:r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spidus</a:t>
                      </a:r>
                      <a:endParaRPr lang="en-US" sz="8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72186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022885.1, CP011410.1, EU747299.1, EU747311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32306846"/>
                  </a:ext>
                </a:extLst>
              </a:tr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P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vironmental wat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72186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022885.1, CP011410.1, EU747299.1, EU747311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27403375"/>
                  </a:ext>
                </a:extLst>
              </a:tr>
              <a:tr h="29981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B-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vironmental wat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72186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022885.1, CP022883.1, CP011410.1, EU747302.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10422268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48BB2B9D-37AA-7643-BA8D-BF72EB0B48E1}"/>
              </a:ext>
            </a:extLst>
          </p:cNvPr>
          <p:cNvSpPr txBox="1"/>
          <p:nvPr/>
        </p:nvSpPr>
        <p:spPr>
          <a:xfrm>
            <a:off x="124693" y="443341"/>
            <a:ext cx="64285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orting Table 1. 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enBank accession numbers of leptospiral </a:t>
            </a:r>
            <a:r>
              <a:rPr lang="en-US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rpo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sequences amplified from positive small wild mammal kidneys and environmental water</a:t>
            </a:r>
          </a:p>
        </p:txBody>
      </p:sp>
    </p:spTree>
    <p:extLst>
      <p:ext uri="{BB962C8B-B14F-4D97-AF65-F5344CB8AC3E}">
        <p14:creationId xmlns:p14="http://schemas.microsoft.com/office/powerpoint/2010/main" val="13754941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96</TotalTime>
  <Words>242</Words>
  <Application>Microsoft Macintosh PowerPoint</Application>
  <PresentationFormat>On-screen Show (4:3)</PresentationFormat>
  <Paragraphs>1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0</cp:revision>
  <dcterms:created xsi:type="dcterms:W3CDTF">2019-11-25T00:55:13Z</dcterms:created>
  <dcterms:modified xsi:type="dcterms:W3CDTF">2019-12-09T23:37:38Z</dcterms:modified>
</cp:coreProperties>
</file>